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1" d="100"/>
          <a:sy n="111" d="100"/>
        </p:scale>
        <p:origin x="-1710" y="-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B2EEE-A661-4A75-8803-037BE0BCF3FB}" type="datetimeFigureOut">
              <a:rPr lang="de-DE" smtClean="0"/>
              <a:t>22.03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0FCF5-062F-4BB2-BE14-E050D9E25F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349730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B2EEE-A661-4A75-8803-037BE0BCF3FB}" type="datetimeFigureOut">
              <a:rPr lang="de-DE" smtClean="0"/>
              <a:t>22.03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0FCF5-062F-4BB2-BE14-E050D9E25F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2272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B2EEE-A661-4A75-8803-037BE0BCF3FB}" type="datetimeFigureOut">
              <a:rPr lang="de-DE" smtClean="0"/>
              <a:t>22.03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0FCF5-062F-4BB2-BE14-E050D9E25F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76588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B2EEE-A661-4A75-8803-037BE0BCF3FB}" type="datetimeFigureOut">
              <a:rPr lang="de-DE" smtClean="0"/>
              <a:t>22.03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0FCF5-062F-4BB2-BE14-E050D9E25F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485834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B2EEE-A661-4A75-8803-037BE0BCF3FB}" type="datetimeFigureOut">
              <a:rPr lang="de-DE" smtClean="0"/>
              <a:t>22.03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0FCF5-062F-4BB2-BE14-E050D9E25F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56281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B2EEE-A661-4A75-8803-037BE0BCF3FB}" type="datetimeFigureOut">
              <a:rPr lang="de-DE" smtClean="0"/>
              <a:t>22.03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0FCF5-062F-4BB2-BE14-E050D9E25F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99962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B2EEE-A661-4A75-8803-037BE0BCF3FB}" type="datetimeFigureOut">
              <a:rPr lang="de-DE" smtClean="0"/>
              <a:t>22.03.2015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0FCF5-062F-4BB2-BE14-E050D9E25F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801871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B2EEE-A661-4A75-8803-037BE0BCF3FB}" type="datetimeFigureOut">
              <a:rPr lang="de-DE" smtClean="0"/>
              <a:t>22.03.2015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0FCF5-062F-4BB2-BE14-E050D9E25F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60628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B2EEE-A661-4A75-8803-037BE0BCF3FB}" type="datetimeFigureOut">
              <a:rPr lang="de-DE" smtClean="0"/>
              <a:t>22.03.2015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0FCF5-062F-4BB2-BE14-E050D9E25F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151268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B2EEE-A661-4A75-8803-037BE0BCF3FB}" type="datetimeFigureOut">
              <a:rPr lang="de-DE" smtClean="0"/>
              <a:t>22.03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0FCF5-062F-4BB2-BE14-E050D9E25F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44467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9B2EEE-A661-4A75-8803-037BE0BCF3FB}" type="datetimeFigureOut">
              <a:rPr lang="de-DE" smtClean="0"/>
              <a:t>22.03.2015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0FCF5-062F-4BB2-BE14-E050D9E25F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2098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9B2EEE-A661-4A75-8803-037BE0BCF3FB}" type="datetimeFigureOut">
              <a:rPr lang="de-DE" smtClean="0"/>
              <a:t>22.03.2015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60FCF5-062F-4BB2-BE14-E050D9E25FC3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79129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uppieren 11"/>
          <p:cNvGrpSpPr/>
          <p:nvPr/>
        </p:nvGrpSpPr>
        <p:grpSpPr>
          <a:xfrm>
            <a:off x="1299012" y="1038642"/>
            <a:ext cx="6321042" cy="5117581"/>
            <a:chOff x="1299012" y="1038642"/>
            <a:chExt cx="6321042" cy="5117581"/>
          </a:xfrm>
        </p:grpSpPr>
        <p:grpSp>
          <p:nvGrpSpPr>
            <p:cNvPr id="37" name="Gruppieren 36"/>
            <p:cNvGrpSpPr/>
            <p:nvPr/>
          </p:nvGrpSpPr>
          <p:grpSpPr>
            <a:xfrm>
              <a:off x="1611993" y="2954222"/>
              <a:ext cx="5899057" cy="923115"/>
              <a:chOff x="376034" y="2217853"/>
              <a:chExt cx="5899057" cy="923115"/>
            </a:xfrm>
          </p:grpSpPr>
          <p:grpSp>
            <p:nvGrpSpPr>
              <p:cNvPr id="29" name="Gruppieren 28"/>
              <p:cNvGrpSpPr/>
              <p:nvPr/>
            </p:nvGrpSpPr>
            <p:grpSpPr>
              <a:xfrm>
                <a:off x="376034" y="2217853"/>
                <a:ext cx="4313605" cy="923115"/>
                <a:chOff x="214293" y="2116349"/>
                <a:chExt cx="4313605" cy="923115"/>
              </a:xfrm>
            </p:grpSpPr>
            <p:pic>
              <p:nvPicPr>
                <p:cNvPr id="1029" name="Picture 5" descr="T:\M.O.I\Arbeitsgruppe\Stammpersonal\Christina\Projekte\HERV\WB\130830_HERV-1D7D11\HERV 1D7D11_Actin.tif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0184" t="25167" r="2470" b="67919"/>
                <a:stretch/>
              </p:blipFill>
              <p:spPr bwMode="auto">
                <a:xfrm>
                  <a:off x="228754" y="2116349"/>
                  <a:ext cx="4299144" cy="38956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33" name="Picture 5" descr="T:\M.O.I\Arbeitsgruppe\Stammpersonal\Christina\Projekte\HERV\WB\130830_HERV-1D7D11\HERV 1D7D11_Actin.tif"/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0184" t="33740" r="2470" b="59476"/>
                <a:stretch/>
              </p:blipFill>
              <p:spPr bwMode="auto">
                <a:xfrm>
                  <a:off x="214293" y="2657212"/>
                  <a:ext cx="4299144" cy="382252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sp>
            <p:nvSpPr>
              <p:cNvPr id="35" name="Textfeld 34"/>
              <p:cNvSpPr txBox="1"/>
              <p:nvPr/>
            </p:nvSpPr>
            <p:spPr>
              <a:xfrm>
                <a:off x="4710752" y="2227968"/>
                <a:ext cx="156433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D7D11 (58 </a:t>
                </a:r>
                <a:r>
                  <a:rPr lang="de-DE" sz="14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de-D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Textfeld 45"/>
              <p:cNvSpPr txBox="1"/>
              <p:nvPr/>
            </p:nvSpPr>
            <p:spPr>
              <a:xfrm>
                <a:off x="4710752" y="2758716"/>
                <a:ext cx="131959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r>
                  <a:rPr lang="de-D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45 </a:t>
                </a:r>
                <a:r>
                  <a:rPr lang="de-DE" sz="14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de-D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9" name="Gruppieren 38"/>
            <p:cNvGrpSpPr/>
            <p:nvPr/>
          </p:nvGrpSpPr>
          <p:grpSpPr>
            <a:xfrm>
              <a:off x="1299012" y="4081155"/>
              <a:ext cx="6116371" cy="1479285"/>
              <a:chOff x="63053" y="3605899"/>
              <a:chExt cx="6116371" cy="1479285"/>
            </a:xfrm>
          </p:grpSpPr>
          <p:grpSp>
            <p:nvGrpSpPr>
              <p:cNvPr id="28" name="Gruppieren 27"/>
              <p:cNvGrpSpPr/>
              <p:nvPr/>
            </p:nvGrpSpPr>
            <p:grpSpPr>
              <a:xfrm>
                <a:off x="63053" y="3605899"/>
                <a:ext cx="4796979" cy="1479285"/>
                <a:chOff x="-98688" y="3389874"/>
                <a:chExt cx="4796979" cy="1479285"/>
              </a:xfrm>
            </p:grpSpPr>
            <p:pic>
              <p:nvPicPr>
                <p:cNvPr id="1032" name="Picture 8" descr="T:\M.O.I\Arbeitsgruppe\Stammpersonal\Christina\Projekte\HERV\WB\130808_Actin.tif"/>
                <p:cNvPicPr>
                  <a:picLocks noChangeAspect="1" noChangeArrowheads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936" t="30007" r="2481" b="54199"/>
                <a:stretch/>
              </p:blipFill>
              <p:spPr bwMode="auto">
                <a:xfrm rot="300000">
                  <a:off x="63315" y="3772649"/>
                  <a:ext cx="4613084" cy="733435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1030" name="Picture 6" descr="T:\M.O.I\Arbeitsgruppe\Stammpersonal\Christina\Projekte\HERV\WB\130815_HERV-1B3.tif"/>
                <p:cNvPicPr>
                  <a:picLocks noChangeAspect="1" noChangeArrowheads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366" t="21405" r="3685" b="69388"/>
                <a:stretch/>
              </p:blipFill>
              <p:spPr bwMode="auto">
                <a:xfrm>
                  <a:off x="177440" y="3554686"/>
                  <a:ext cx="4428020" cy="427578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7" name="Rechteck 16"/>
                <p:cNvSpPr/>
                <p:nvPr/>
              </p:nvSpPr>
              <p:spPr>
                <a:xfrm>
                  <a:off x="-98688" y="3389874"/>
                  <a:ext cx="327078" cy="1318499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6" name="Rechteck 25"/>
                <p:cNvSpPr/>
                <p:nvPr/>
              </p:nvSpPr>
              <p:spPr>
                <a:xfrm>
                  <a:off x="4522120" y="3472279"/>
                  <a:ext cx="176171" cy="139688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7" name="Rechteck 26"/>
                <p:cNvSpPr/>
                <p:nvPr/>
              </p:nvSpPr>
              <p:spPr>
                <a:xfrm>
                  <a:off x="177440" y="4312760"/>
                  <a:ext cx="4520851" cy="39596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Rechteck 37"/>
                <p:cNvSpPr/>
                <p:nvPr/>
              </p:nvSpPr>
              <p:spPr>
                <a:xfrm>
                  <a:off x="185377" y="3874636"/>
                  <a:ext cx="4344864" cy="14499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30" name="Textfeld 29"/>
              <p:cNvSpPr txBox="1"/>
              <p:nvPr/>
            </p:nvSpPr>
            <p:spPr>
              <a:xfrm>
                <a:off x="4710752" y="3736181"/>
                <a:ext cx="146867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B3H7 </a:t>
                </a:r>
                <a:r>
                  <a:rPr lang="de-D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(58 </a:t>
                </a:r>
                <a:r>
                  <a:rPr lang="de-DE" sz="14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de-D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Textfeld 46"/>
              <p:cNvSpPr txBox="1"/>
              <p:nvPr/>
            </p:nvSpPr>
            <p:spPr>
              <a:xfrm>
                <a:off x="4710752" y="4194043"/>
                <a:ext cx="131959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r>
                  <a:rPr lang="de-D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45 </a:t>
                </a:r>
                <a:r>
                  <a:rPr lang="de-DE" sz="14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de-D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0" name="Gruppieren 39"/>
            <p:cNvGrpSpPr/>
            <p:nvPr/>
          </p:nvGrpSpPr>
          <p:grpSpPr>
            <a:xfrm>
              <a:off x="1397700" y="1556792"/>
              <a:ext cx="6222354" cy="1269554"/>
              <a:chOff x="161741" y="5039766"/>
              <a:chExt cx="6222354" cy="1269554"/>
            </a:xfrm>
          </p:grpSpPr>
          <p:sp>
            <p:nvSpPr>
              <p:cNvPr id="19" name="Textfeld 18"/>
              <p:cNvSpPr txBox="1"/>
              <p:nvPr/>
            </p:nvSpPr>
            <p:spPr>
              <a:xfrm>
                <a:off x="4710752" y="5313823"/>
                <a:ext cx="1673343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4H11G1 (58 </a:t>
                </a:r>
                <a:r>
                  <a:rPr lang="de-DE" sz="14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de-D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4" name="Gruppieren 33"/>
              <p:cNvGrpSpPr/>
              <p:nvPr/>
            </p:nvGrpSpPr>
            <p:grpSpPr>
              <a:xfrm>
                <a:off x="161741" y="5039766"/>
                <a:ext cx="4642483" cy="1269554"/>
                <a:chOff x="161741" y="5039766"/>
                <a:chExt cx="4642483" cy="1269554"/>
              </a:xfrm>
            </p:grpSpPr>
            <p:grpSp>
              <p:nvGrpSpPr>
                <p:cNvPr id="25" name="Gruppieren 24"/>
                <p:cNvGrpSpPr/>
                <p:nvPr/>
              </p:nvGrpSpPr>
              <p:grpSpPr>
                <a:xfrm>
                  <a:off x="161741" y="5039766"/>
                  <a:ext cx="4605460" cy="1269554"/>
                  <a:chOff x="0" y="5039766"/>
                  <a:chExt cx="4605460" cy="1269554"/>
                </a:xfrm>
              </p:grpSpPr>
              <p:pic>
                <p:nvPicPr>
                  <p:cNvPr id="1027" name="Picture 3" descr="T:\M.O.I\Arbeitsgruppe\Stammpersonal\Christina\Projekte\HERV\WB\130830_HERV-14H11G1\Actin_2.tif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515" t="40704" r="8493" b="46462"/>
                  <a:stretch/>
                </p:blipFill>
                <p:spPr bwMode="auto">
                  <a:xfrm rot="21420000">
                    <a:off x="105515" y="5554578"/>
                    <a:ext cx="4432271" cy="639196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1026" name="Picture 2" descr="T:\M.O.I\Arbeitsgruppe\Stammpersonal\Christina\Projekte\HERV\WB\130819_HERV-14H.tif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0170" t="27835" r="2962" b="56054"/>
                  <a:stretch/>
                </p:blipFill>
                <p:spPr bwMode="auto">
                  <a:xfrm rot="120000">
                    <a:off x="203753" y="5115078"/>
                    <a:ext cx="4326497" cy="601763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10" name="Rechteck 9"/>
                  <p:cNvSpPr/>
                  <p:nvPr/>
                </p:nvSpPr>
                <p:spPr>
                  <a:xfrm>
                    <a:off x="194570" y="5637331"/>
                    <a:ext cx="4344864" cy="144991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de-DE" sz="14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" name="Rechteck 10"/>
                  <p:cNvSpPr/>
                  <p:nvPr/>
                </p:nvSpPr>
                <p:spPr>
                  <a:xfrm>
                    <a:off x="194570" y="6071319"/>
                    <a:ext cx="4344863" cy="238001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de-DE" sz="14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" name="Rechteck 6"/>
                  <p:cNvSpPr/>
                  <p:nvPr/>
                </p:nvSpPr>
                <p:spPr>
                  <a:xfrm>
                    <a:off x="194570" y="5039766"/>
                    <a:ext cx="4410890" cy="320596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de-DE" sz="14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" name="Rechteck 12"/>
                  <p:cNvSpPr/>
                  <p:nvPr/>
                </p:nvSpPr>
                <p:spPr>
                  <a:xfrm>
                    <a:off x="0" y="5256922"/>
                    <a:ext cx="214293" cy="105239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de-DE" sz="14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8" name="Rechteck 7"/>
                <p:cNvSpPr/>
                <p:nvPr/>
              </p:nvSpPr>
              <p:spPr>
                <a:xfrm>
                  <a:off x="4675180" y="5062054"/>
                  <a:ext cx="129044" cy="1150553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14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48" name="Textfeld 47"/>
              <p:cNvSpPr txBox="1"/>
              <p:nvPr/>
            </p:nvSpPr>
            <p:spPr>
              <a:xfrm>
                <a:off x="4710752" y="5734369"/>
                <a:ext cx="131959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r>
                  <a:rPr lang="de-D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45 </a:t>
                </a:r>
                <a:r>
                  <a:rPr lang="de-DE" sz="14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de-D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" name="Gruppieren 3"/>
            <p:cNvGrpSpPr/>
            <p:nvPr/>
          </p:nvGrpSpPr>
          <p:grpSpPr>
            <a:xfrm>
              <a:off x="1550034" y="1038642"/>
              <a:ext cx="5095170" cy="331020"/>
              <a:chOff x="1550034" y="1038642"/>
              <a:chExt cx="5095170" cy="331020"/>
            </a:xfrm>
          </p:grpSpPr>
          <p:sp>
            <p:nvSpPr>
              <p:cNvPr id="57" name="Textfeld 2"/>
              <p:cNvSpPr txBox="1">
                <a:spLocks noChangeArrowheads="1"/>
              </p:cNvSpPr>
              <p:nvPr/>
            </p:nvSpPr>
            <p:spPr bwMode="auto">
              <a:xfrm rot="19156702">
                <a:off x="1550034" y="1044803"/>
                <a:ext cx="1180800" cy="324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1pPr>
                <a:lvl2pPr marL="742950" indent="-28575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2pPr>
                <a:lvl3pPr marL="11430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3pPr>
                <a:lvl4pPr marL="16002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4pPr>
                <a:lvl5pPr marL="20574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9pPr>
              </a:lstStyle>
              <a:p>
                <a:r>
                  <a:rPr lang="de-DE" alt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HROC40</a:t>
                </a:r>
              </a:p>
            </p:txBody>
          </p:sp>
          <p:sp>
            <p:nvSpPr>
              <p:cNvPr id="58" name="Textfeld 15"/>
              <p:cNvSpPr txBox="1">
                <a:spLocks noChangeArrowheads="1"/>
              </p:cNvSpPr>
              <p:nvPr/>
            </p:nvSpPr>
            <p:spPr bwMode="auto">
              <a:xfrm rot="19156702">
                <a:off x="1941471" y="1044803"/>
                <a:ext cx="1180800" cy="324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1pPr>
                <a:lvl2pPr marL="742950" indent="-28575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2pPr>
                <a:lvl3pPr marL="11430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3pPr>
                <a:lvl4pPr marL="16002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4pPr>
                <a:lvl5pPr marL="20574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9pPr>
              </a:lstStyle>
              <a:p>
                <a:r>
                  <a:rPr lang="de-DE" alt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HROC32</a:t>
                </a:r>
              </a:p>
            </p:txBody>
          </p:sp>
          <p:sp>
            <p:nvSpPr>
              <p:cNvPr id="59" name="Textfeld 16"/>
              <p:cNvSpPr txBox="1">
                <a:spLocks noChangeArrowheads="1"/>
              </p:cNvSpPr>
              <p:nvPr/>
            </p:nvSpPr>
            <p:spPr bwMode="auto">
              <a:xfrm rot="19156702">
                <a:off x="2332908" y="1044803"/>
                <a:ext cx="1180800" cy="324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1pPr>
                <a:lvl2pPr marL="742950" indent="-28575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2pPr>
                <a:lvl3pPr marL="11430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3pPr>
                <a:lvl4pPr marL="16002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4pPr>
                <a:lvl5pPr marL="20574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9pPr>
              </a:lstStyle>
              <a:p>
                <a:r>
                  <a:rPr lang="de-DE" alt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HROC57</a:t>
                </a:r>
              </a:p>
            </p:txBody>
          </p:sp>
          <p:sp>
            <p:nvSpPr>
              <p:cNvPr id="60" name="Textfeld 17"/>
              <p:cNvSpPr txBox="1">
                <a:spLocks noChangeArrowheads="1"/>
              </p:cNvSpPr>
              <p:nvPr/>
            </p:nvSpPr>
            <p:spPr bwMode="auto">
              <a:xfrm rot="19156702">
                <a:off x="2724345" y="1044803"/>
                <a:ext cx="1180800" cy="324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1pPr>
                <a:lvl2pPr marL="742950" indent="-28575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2pPr>
                <a:lvl3pPr marL="11430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3pPr>
                <a:lvl4pPr marL="16002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4pPr>
                <a:lvl5pPr marL="20574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9pPr>
              </a:lstStyle>
              <a:p>
                <a:r>
                  <a:rPr lang="de-DE" alt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HROC87</a:t>
                </a:r>
              </a:p>
            </p:txBody>
          </p:sp>
          <p:sp>
            <p:nvSpPr>
              <p:cNvPr id="61" name="Textfeld 18"/>
              <p:cNvSpPr txBox="1">
                <a:spLocks noChangeArrowheads="1"/>
              </p:cNvSpPr>
              <p:nvPr/>
            </p:nvSpPr>
            <p:spPr bwMode="auto">
              <a:xfrm rot="19156702">
                <a:off x="3115782" y="1043038"/>
                <a:ext cx="1180800" cy="324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1pPr>
                <a:lvl2pPr marL="742950" indent="-28575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2pPr>
                <a:lvl3pPr marL="11430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3pPr>
                <a:lvl4pPr marL="16002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4pPr>
                <a:lvl5pPr marL="20574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9pPr>
              </a:lstStyle>
              <a:p>
                <a:r>
                  <a:rPr lang="de-DE" alt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HROC107</a:t>
                </a:r>
              </a:p>
            </p:txBody>
          </p:sp>
          <p:sp>
            <p:nvSpPr>
              <p:cNvPr id="62" name="Textfeld 19"/>
              <p:cNvSpPr txBox="1">
                <a:spLocks noChangeArrowheads="1"/>
              </p:cNvSpPr>
              <p:nvPr/>
            </p:nvSpPr>
            <p:spPr bwMode="auto">
              <a:xfrm rot="19156702">
                <a:off x="3507219" y="1043038"/>
                <a:ext cx="1180800" cy="324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1pPr>
                <a:lvl2pPr marL="742950" indent="-28575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2pPr>
                <a:lvl3pPr marL="11430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3pPr>
                <a:lvl4pPr marL="16002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4pPr>
                <a:lvl5pPr marL="20574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9pPr>
              </a:lstStyle>
              <a:p>
                <a:r>
                  <a:rPr lang="de-DE" alt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HROC126</a:t>
                </a:r>
              </a:p>
            </p:txBody>
          </p:sp>
          <p:sp>
            <p:nvSpPr>
              <p:cNvPr id="63" name="Textfeld 20"/>
              <p:cNvSpPr txBox="1">
                <a:spLocks noChangeArrowheads="1"/>
              </p:cNvSpPr>
              <p:nvPr/>
            </p:nvSpPr>
            <p:spPr bwMode="auto">
              <a:xfrm rot="19156702">
                <a:off x="3898656" y="1043038"/>
                <a:ext cx="1180800" cy="324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1pPr>
                <a:lvl2pPr marL="742950" indent="-28575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2pPr>
                <a:lvl3pPr marL="11430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3pPr>
                <a:lvl4pPr marL="16002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4pPr>
                <a:lvl5pPr marL="20574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9pPr>
              </a:lstStyle>
              <a:p>
                <a:r>
                  <a:rPr lang="de-DE" alt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HROC131</a:t>
                </a:r>
              </a:p>
            </p:txBody>
          </p:sp>
          <p:sp>
            <p:nvSpPr>
              <p:cNvPr id="64" name="Textfeld 21"/>
              <p:cNvSpPr txBox="1">
                <a:spLocks noChangeArrowheads="1"/>
              </p:cNvSpPr>
              <p:nvPr/>
            </p:nvSpPr>
            <p:spPr bwMode="auto">
              <a:xfrm rot="19156702">
                <a:off x="4290093" y="1043038"/>
                <a:ext cx="1180800" cy="324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1pPr>
                <a:lvl2pPr marL="742950" indent="-28575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2pPr>
                <a:lvl3pPr marL="11430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3pPr>
                <a:lvl4pPr marL="16002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4pPr>
                <a:lvl5pPr marL="20574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9pPr>
              </a:lstStyle>
              <a:p>
                <a:r>
                  <a:rPr lang="de-DE" alt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HROC183</a:t>
                </a:r>
              </a:p>
            </p:txBody>
          </p:sp>
          <p:sp>
            <p:nvSpPr>
              <p:cNvPr id="65" name="Textfeld 22"/>
              <p:cNvSpPr txBox="1">
                <a:spLocks noChangeArrowheads="1"/>
              </p:cNvSpPr>
              <p:nvPr/>
            </p:nvSpPr>
            <p:spPr bwMode="auto">
              <a:xfrm rot="19156702">
                <a:off x="4681530" y="1043038"/>
                <a:ext cx="1180800" cy="324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1pPr>
                <a:lvl2pPr marL="742950" indent="-28575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2pPr>
                <a:lvl3pPr marL="11430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3pPr>
                <a:lvl4pPr marL="16002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4pPr>
                <a:lvl5pPr marL="20574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9pPr>
              </a:lstStyle>
              <a:p>
                <a:r>
                  <a:rPr lang="de-DE" alt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HROC212</a:t>
                </a:r>
              </a:p>
            </p:txBody>
          </p:sp>
          <p:sp>
            <p:nvSpPr>
              <p:cNvPr id="66" name="Textfeld 23"/>
              <p:cNvSpPr txBox="1">
                <a:spLocks noChangeArrowheads="1"/>
              </p:cNvSpPr>
              <p:nvPr/>
            </p:nvSpPr>
            <p:spPr bwMode="auto">
              <a:xfrm rot="19156702">
                <a:off x="5072967" y="1045662"/>
                <a:ext cx="1180800" cy="324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1pPr>
                <a:lvl2pPr marL="742950" indent="-28575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2pPr>
                <a:lvl3pPr marL="11430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3pPr>
                <a:lvl4pPr marL="16002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4pPr>
                <a:lvl5pPr marL="20574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9pPr>
              </a:lstStyle>
              <a:p>
                <a:r>
                  <a:rPr lang="de-DE" alt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HHC6548</a:t>
                </a:r>
              </a:p>
            </p:txBody>
          </p:sp>
          <p:sp>
            <p:nvSpPr>
              <p:cNvPr id="67" name="Textfeld 24"/>
              <p:cNvSpPr txBox="1">
                <a:spLocks noChangeArrowheads="1"/>
              </p:cNvSpPr>
              <p:nvPr/>
            </p:nvSpPr>
            <p:spPr bwMode="auto">
              <a:xfrm rot="19156702">
                <a:off x="5464404" y="1038642"/>
                <a:ext cx="1180800" cy="324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1pPr>
                <a:lvl2pPr marL="742950" indent="-28575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2pPr>
                <a:lvl3pPr marL="11430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3pPr>
                <a:lvl4pPr marL="16002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4pPr>
                <a:lvl5pPr marL="2057400" indent="-228600"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pitchFamily="34" charset="-128"/>
                  </a:defRPr>
                </a:lvl9pPr>
              </a:lstStyle>
              <a:p>
                <a:r>
                  <a:rPr lang="de-DE" alt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HROBMC01</a:t>
                </a:r>
              </a:p>
            </p:txBody>
          </p:sp>
        </p:grpSp>
        <p:grpSp>
          <p:nvGrpSpPr>
            <p:cNvPr id="9" name="Gruppieren 8"/>
            <p:cNvGrpSpPr/>
            <p:nvPr/>
          </p:nvGrpSpPr>
          <p:grpSpPr>
            <a:xfrm>
              <a:off x="1620335" y="5347578"/>
              <a:ext cx="5804666" cy="808645"/>
              <a:chOff x="1620335" y="5517232"/>
              <a:chExt cx="5804666" cy="808645"/>
            </a:xfrm>
          </p:grpSpPr>
          <p:grpSp>
            <p:nvGrpSpPr>
              <p:cNvPr id="31" name="Gruppieren 30"/>
              <p:cNvGrpSpPr/>
              <p:nvPr/>
            </p:nvGrpSpPr>
            <p:grpSpPr>
              <a:xfrm>
                <a:off x="1620335" y="5546728"/>
                <a:ext cx="4316799" cy="779149"/>
                <a:chOff x="222635" y="764704"/>
                <a:chExt cx="4316799" cy="779149"/>
              </a:xfrm>
            </p:grpSpPr>
            <p:pic>
              <p:nvPicPr>
                <p:cNvPr id="1031" name="Picture 7" descr="T:\M.O.I\Arbeitsgruppe\Stammpersonal\Christina\Projekte\HERV\WB\130830_control-2G2B3\2G2B3_Actin.tif"/>
                <p:cNvPicPr>
                  <a:picLocks noChangeAspect="1" noChangeArrowheads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378" t="23938" r="10123" b="68821"/>
                <a:stretch/>
              </p:blipFill>
              <p:spPr bwMode="auto">
                <a:xfrm>
                  <a:off x="222635" y="764704"/>
                  <a:ext cx="4316799" cy="326412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21" name="Picture 7" descr="T:\M.O.I\Arbeitsgruppe\Stammpersonal\Christina\Projekte\HERV\WB\130830_control-2G2B3\2G2B3_Actin.tif"/>
                <p:cNvPicPr>
                  <a:picLocks noChangeAspect="1" noChangeArrowheads="1"/>
                </p:cNvPicPr>
                <p:nvPr/>
              </p:nvPicPr>
              <p:blipFill rotWithShape="1"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923" t="39520" r="9580" b="53286"/>
                <a:stretch/>
              </p:blipFill>
              <p:spPr bwMode="auto">
                <a:xfrm>
                  <a:off x="222635" y="1219600"/>
                  <a:ext cx="4316799" cy="324253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sp>
            <p:nvSpPr>
              <p:cNvPr id="32" name="Textfeld 31"/>
              <p:cNvSpPr txBox="1"/>
              <p:nvPr/>
            </p:nvSpPr>
            <p:spPr>
              <a:xfrm>
                <a:off x="5946711" y="5517232"/>
                <a:ext cx="147829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G2B3 (58 </a:t>
                </a:r>
                <a:r>
                  <a:rPr lang="de-DE" sz="14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de-D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feld 44"/>
              <p:cNvSpPr txBox="1"/>
              <p:nvPr/>
            </p:nvSpPr>
            <p:spPr>
              <a:xfrm>
                <a:off x="5946711" y="5979084"/>
                <a:ext cx="131959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Actin</a:t>
                </a:r>
                <a:r>
                  <a:rPr lang="de-D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(45 </a:t>
                </a:r>
                <a:r>
                  <a:rPr lang="de-DE" sz="14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de-DE" sz="14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37095455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1</Words>
  <Application>Microsoft Office PowerPoint</Application>
  <PresentationFormat>Bildschirmpräsentation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Christina Mullins</dc:creator>
  <cp:lastModifiedBy>Christina</cp:lastModifiedBy>
  <cp:revision>16</cp:revision>
  <dcterms:created xsi:type="dcterms:W3CDTF">2013-09-04T06:42:29Z</dcterms:created>
  <dcterms:modified xsi:type="dcterms:W3CDTF">2015-03-22T14:37:32Z</dcterms:modified>
</cp:coreProperties>
</file>